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87" r:id="rId3"/>
    <p:sldId id="256" r:id="rId4"/>
    <p:sldId id="28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1"/>
    <p:restoredTop sz="95872"/>
  </p:normalViewPr>
  <p:slideViewPr>
    <p:cSldViewPr snapToGrid="0" snapToObjects="1">
      <p:cViewPr varScale="1">
        <p:scale>
          <a:sx n="91" d="100"/>
          <a:sy n="91" d="100"/>
        </p:scale>
        <p:origin x="224" y="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7D760E-85DE-064A-AF7F-DDA1A8C0FA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DC432E-E273-D647-83CB-61F0ED4E2C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DA7B5-AB24-904A-8E3E-5924D2BE8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2018E0-0255-6E47-85F5-5C3DFD03F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129EDC-5CEA-DA49-88FC-3BB8C3B704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18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5FC6ED-206F-634D-9FCD-28C5B9FFEF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BE469B-2E2F-E947-B0C9-F6C7E1510E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1B8885-C258-3A44-895E-1CA7440B6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2A6051-97E2-564F-9668-CBE0F4905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EF92FB-1231-9C43-9829-E6F5E36CB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167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621116-5FEE-0245-9436-D670F9F324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B17F13-1685-3848-816C-6832291721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180FC2-AE9D-3143-BB67-EE37B1C1D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8A1253-EA16-DA40-A531-1A5DEFEAF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1E1E3-4918-3144-88F6-FCBE3C68A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507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9F2859-AA02-5842-9A8F-15A3CDC3C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E79412-0070-8F47-9E60-CB2BE7B471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E41D8-DFAE-7647-9CCE-489865BCA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56F023-A967-E043-89DF-560249068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56C52E-4164-6A49-BFCB-5A6C529FC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662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CBE26-77BB-A542-B618-88CC67B73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093BCC-3C3D-5741-B550-10AFF11393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456F0-6FA9-A44D-A1F5-DA6BC85FF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E13580-9564-BA46-8B34-115F55640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7D41C5-D379-1B43-9259-6A5BFEF22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826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29F27-9E5A-4A4E-8A58-412349E6C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40F4E0-1F67-DF4E-A373-F4796396FE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18AF1C-7430-414E-B9B2-048B4748A4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F111F0-D5F0-DD40-9331-02B5F1302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664975-571E-DD4B-8C9A-EA0731431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D1857D-B0EB-EB45-9EF1-00C59FED5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698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4B01C-BF6D-524A-B470-C7D4C1C2A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CB3C65-1B8A-B240-9A60-DCFF06CCC4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C31AE2-ED5C-9446-BF5D-776F884E9F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7634A8-F06A-8B4E-9FFB-8CEDBA2998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E1FE11-D483-E244-960D-DD40C77D0B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4EF8BD-D636-5D4B-8574-E86F1A60C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40FE0C-5C40-DB43-B9E5-56E9012C2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0396D1-5360-EF4B-BB55-7263CB3BC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322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E22476-7024-5140-BCD0-C6EB50C59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3DC027-FEDC-5642-A67C-02880402A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15F6EB-150D-414A-9588-66E2D3525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7B3A9E-F680-C342-8E15-995131ECB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75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BC2700-B560-1D49-9E34-B7E17ECB0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7F5631-D4C4-5C48-BF35-6F008838E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7AB7F9-CE77-2A48-9FAA-F053C2D81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270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5D7D08-647F-C34C-A223-3634E8F9B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94EAC9-D89D-D24F-8E74-0EAE136CB9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78AC10-719C-5C40-86D6-6D5A91420D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D0C904-BFFE-B841-911C-BBE27D5C4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F0F528-5DF9-734F-8924-F6A1010BD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16E199-2B2D-FE43-9EEE-5D18A8970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340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C645D2-0F79-3B4F-A01F-12F79DB55C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2130312-D831-B04D-A0E1-5CBEE0245F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30EE72-FF35-C549-ADC0-B3ED95F561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6E6BB6-55BA-1C4B-A3D5-BE5D48669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52045B-9D14-174E-8352-0F73F8266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942DFF-D075-864B-85FF-5C1159518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713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97E23D7-73D3-2545-B13A-5568D270B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A27BEB-86ED-404B-BFA4-9063C4A7DD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C2B83-B718-B849-9B8E-F17C3665FD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FB99C-DACD-5F49-81DD-D9E4332D04AE}" type="datetimeFigureOut">
              <a:rPr lang="en-US" smtClean="0"/>
              <a:t>6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174500-4534-8643-8A37-176AF755E7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B3F8F-8193-434F-98A5-7EF91CD73B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DAC91-03A3-234F-8076-7513675FE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204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FB7A4CB7-6755-F647-9FFB-B458E7932613}"/>
              </a:ext>
            </a:extLst>
          </p:cNvPr>
          <p:cNvSpPr txBox="1"/>
          <p:nvPr/>
        </p:nvSpPr>
        <p:spPr>
          <a:xfrm>
            <a:off x="253218" y="196948"/>
            <a:ext cx="3284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E22B749-A7CA-BF48-B2E9-1F735A1899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2376"/>
          <a:stretch/>
        </p:blipFill>
        <p:spPr>
          <a:xfrm>
            <a:off x="5803819" y="1349110"/>
            <a:ext cx="5942304" cy="598133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F526749-65A7-0F40-A1CA-5021FCEC4C3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0851"/>
          <a:stretch/>
        </p:blipFill>
        <p:spPr>
          <a:xfrm>
            <a:off x="356746" y="1112778"/>
            <a:ext cx="6058122" cy="6217670"/>
          </a:xfrm>
          <a:prstGeom prst="rect">
            <a:avLst/>
          </a:prstGeom>
        </p:spPr>
      </p:pic>
      <p:sp>
        <p:nvSpPr>
          <p:cNvPr id="5" name="CasellaDiTesto 10">
            <a:extLst>
              <a:ext uri="{FF2B5EF4-FFF2-40B4-BE49-F238E27FC236}">
                <a16:creationId xmlns:a16="http://schemas.microsoft.com/office/drawing/2014/main" id="{C53CDAB6-EF90-E245-A039-9BE585BE61A6}"/>
              </a:ext>
            </a:extLst>
          </p:cNvPr>
          <p:cNvSpPr txBox="1"/>
          <p:nvPr/>
        </p:nvSpPr>
        <p:spPr>
          <a:xfrm>
            <a:off x="472564" y="1112778"/>
            <a:ext cx="6890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CasellaDiTesto 10">
            <a:extLst>
              <a:ext uri="{FF2B5EF4-FFF2-40B4-BE49-F238E27FC236}">
                <a16:creationId xmlns:a16="http://schemas.microsoft.com/office/drawing/2014/main" id="{058736CE-06D6-A440-B9FE-87EE61D7F34B}"/>
              </a:ext>
            </a:extLst>
          </p:cNvPr>
          <p:cNvSpPr txBox="1"/>
          <p:nvPr/>
        </p:nvSpPr>
        <p:spPr>
          <a:xfrm>
            <a:off x="5841659" y="1112778"/>
            <a:ext cx="6890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464964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7E8FC20-07D2-C44F-9ABC-783DC2724188}"/>
              </a:ext>
            </a:extLst>
          </p:cNvPr>
          <p:cNvSpPr txBox="1"/>
          <p:nvPr/>
        </p:nvSpPr>
        <p:spPr>
          <a:xfrm>
            <a:off x="253218" y="196948"/>
            <a:ext cx="3284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0AC8835-6B57-6A4C-BF0C-D5671F31701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8307"/>
          <a:stretch/>
        </p:blipFill>
        <p:spPr>
          <a:xfrm>
            <a:off x="2438765" y="1044745"/>
            <a:ext cx="6480153" cy="6024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69114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27">
            <a:extLst>
              <a:ext uri="{FF2B5EF4-FFF2-40B4-BE49-F238E27FC236}">
                <a16:creationId xmlns:a16="http://schemas.microsoft.com/office/drawing/2014/main" id="{11EC9C58-50FD-7E43-96D5-8319031C89AC}"/>
              </a:ext>
            </a:extLst>
          </p:cNvPr>
          <p:cNvSpPr txBox="1"/>
          <p:nvPr/>
        </p:nvSpPr>
        <p:spPr>
          <a:xfrm>
            <a:off x="4524154" y="1624201"/>
            <a:ext cx="17352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&lt; 0.01; </a:t>
            </a:r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 = 0.71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52B74819-FC83-7D4A-9E7C-1F25BB1C57FD}"/>
              </a:ext>
            </a:extLst>
          </p:cNvPr>
          <p:cNvGrpSpPr/>
          <p:nvPr/>
        </p:nvGrpSpPr>
        <p:grpSpPr>
          <a:xfrm>
            <a:off x="2968224" y="1336923"/>
            <a:ext cx="4477820" cy="3727446"/>
            <a:chOff x="9009841" y="3765336"/>
            <a:chExt cx="3123688" cy="2567234"/>
          </a:xfrm>
        </p:grpSpPr>
        <p:pic>
          <p:nvPicPr>
            <p:cNvPr id="6" name="Immagine 3">
              <a:extLst>
                <a:ext uri="{FF2B5EF4-FFF2-40B4-BE49-F238E27FC236}">
                  <a16:creationId xmlns:a16="http://schemas.microsoft.com/office/drawing/2014/main" id="{67F7D9E7-A5A5-E342-86CB-E01CDBCE98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009842" y="3765336"/>
              <a:ext cx="3123687" cy="256723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CC92C93-C968-2C4B-969B-087A09E1E29A}"/>
                </a:ext>
              </a:extLst>
            </p:cNvPr>
            <p:cNvSpPr txBox="1"/>
            <p:nvPr/>
          </p:nvSpPr>
          <p:spPr>
            <a:xfrm rot="16200000">
              <a:off x="8041437" y="4744849"/>
              <a:ext cx="2194452" cy="25764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CE2 (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dirty="0">
                  <a:latin typeface="Symbol" pitchFamily="2" charset="2"/>
                  <a:cs typeface="Arial" panose="020B0604020202020204" pitchFamily="34" charset="0"/>
                </a:rPr>
                <a:t>m</a:t>
              </a: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g of Total Protein)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1E743719-8FE1-924C-B7EB-5E7C6CD7A3D5}"/>
              </a:ext>
            </a:extLst>
          </p:cNvPr>
          <p:cNvSpPr txBox="1"/>
          <p:nvPr/>
        </p:nvSpPr>
        <p:spPr>
          <a:xfrm>
            <a:off x="253218" y="196948"/>
            <a:ext cx="3284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</p:spTree>
    <p:extLst>
      <p:ext uri="{BB962C8B-B14F-4D97-AF65-F5344CB8AC3E}">
        <p14:creationId xmlns:p14="http://schemas.microsoft.com/office/powerpoint/2010/main" val="9179641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40A3942A-EF40-8E49-859C-8DA6C64479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782" t="28154" r="34268" b="37783"/>
          <a:stretch/>
        </p:blipFill>
        <p:spPr>
          <a:xfrm>
            <a:off x="4143359" y="2367602"/>
            <a:ext cx="1768390" cy="142989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5CDA8BC-B93F-0642-B492-725C65BB5A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8583" t="9574" r="24813" b="39220"/>
          <a:stretch/>
        </p:blipFill>
        <p:spPr>
          <a:xfrm>
            <a:off x="4149201" y="911651"/>
            <a:ext cx="1771320" cy="142989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3E7E294-5150-1B4E-9734-E9C3E5055FA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039" t="20912" r="28287" b="17495"/>
          <a:stretch/>
        </p:blipFill>
        <p:spPr>
          <a:xfrm>
            <a:off x="5986845" y="891188"/>
            <a:ext cx="1755238" cy="142989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36F52CE-CF71-924F-A108-C854A5F1E89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9948" t="19711" r="19587" b="46511"/>
          <a:stretch/>
        </p:blipFill>
        <p:spPr>
          <a:xfrm>
            <a:off x="5986845" y="2367602"/>
            <a:ext cx="1755238" cy="142989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BCE213D-A495-1245-80D5-59BB9FDEE09E}"/>
              </a:ext>
            </a:extLst>
          </p:cNvPr>
          <p:cNvSpPr txBox="1"/>
          <p:nvPr/>
        </p:nvSpPr>
        <p:spPr>
          <a:xfrm>
            <a:off x="2403157" y="1410259"/>
            <a:ext cx="1959094" cy="4861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ham-treated 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BEC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008380-BD96-B349-8FA1-C25F3B6057B3}"/>
              </a:ext>
            </a:extLst>
          </p:cNvPr>
          <p:cNvSpPr txBox="1"/>
          <p:nvPr/>
        </p:nvSpPr>
        <p:spPr>
          <a:xfrm>
            <a:off x="2961205" y="2700194"/>
            <a:ext cx="998523" cy="2814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S-treate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316F19-BC0A-254F-A383-F0487C4E1E35}"/>
              </a:ext>
            </a:extLst>
          </p:cNvPr>
          <p:cNvSpPr txBox="1"/>
          <p:nvPr/>
        </p:nvSpPr>
        <p:spPr>
          <a:xfrm>
            <a:off x="5202317" y="916473"/>
            <a:ext cx="668039" cy="2558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92D050"/>
                </a:solidFill>
                <a:latin typeface="Symbol" pitchFamily="2" charset="2"/>
                <a:cs typeface="Arial" panose="020B0604020202020204" pitchFamily="34" charset="0"/>
              </a:rPr>
              <a:t>g</a:t>
            </a:r>
            <a:r>
              <a:rPr lang="en-US" sz="14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2AX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1483502-C868-C648-AA5A-65BAC03E4764}"/>
              </a:ext>
            </a:extLst>
          </p:cNvPr>
          <p:cNvSpPr txBox="1"/>
          <p:nvPr/>
        </p:nvSpPr>
        <p:spPr>
          <a:xfrm>
            <a:off x="5200948" y="2316776"/>
            <a:ext cx="668039" cy="2558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92D050"/>
                </a:solidFill>
                <a:latin typeface="Symbol" pitchFamily="2" charset="2"/>
                <a:cs typeface="Arial" panose="020B0604020202020204" pitchFamily="34" charset="0"/>
              </a:rPr>
              <a:t>g</a:t>
            </a:r>
            <a:r>
              <a:rPr lang="en-US" sz="14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H2AX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26A402-BE35-8349-99DE-17CA3551EAAA}"/>
              </a:ext>
            </a:extLst>
          </p:cNvPr>
          <p:cNvSpPr txBox="1"/>
          <p:nvPr/>
        </p:nvSpPr>
        <p:spPr>
          <a:xfrm>
            <a:off x="6406101" y="911651"/>
            <a:ext cx="1144044" cy="2558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 contro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EA1CABC-3650-2845-8EA0-2BE4F8135942}"/>
              </a:ext>
            </a:extLst>
          </p:cNvPr>
          <p:cNvSpPr txBox="1"/>
          <p:nvPr/>
        </p:nvSpPr>
        <p:spPr>
          <a:xfrm>
            <a:off x="6449031" y="2330844"/>
            <a:ext cx="1178046" cy="2558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otype contro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336F9CB-F75F-404A-93AD-D7A9A6BB3D26}"/>
              </a:ext>
            </a:extLst>
          </p:cNvPr>
          <p:cNvSpPr txBox="1"/>
          <p:nvPr/>
        </p:nvSpPr>
        <p:spPr>
          <a:xfrm>
            <a:off x="253218" y="196948"/>
            <a:ext cx="3284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</p:spTree>
    <p:extLst>
      <p:ext uri="{BB962C8B-B14F-4D97-AF65-F5344CB8AC3E}">
        <p14:creationId xmlns:p14="http://schemas.microsoft.com/office/powerpoint/2010/main" val="6449917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67</TotalTime>
  <Words>39</Words>
  <Application>Microsoft Macintosh PowerPoint</Application>
  <PresentationFormat>Widescreen</PresentationFormat>
  <Paragraphs>1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olverino</dc:creator>
  <cp:lastModifiedBy>Francesca Polverino</cp:lastModifiedBy>
  <cp:revision>11</cp:revision>
  <dcterms:created xsi:type="dcterms:W3CDTF">2021-06-10T21:39:39Z</dcterms:created>
  <dcterms:modified xsi:type="dcterms:W3CDTF">2021-07-14T13:39:36Z</dcterms:modified>
</cp:coreProperties>
</file>